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7"/>
  </p:notesMasterIdLst>
  <p:sldIdLst>
    <p:sldId id="266" r:id="rId2"/>
    <p:sldId id="269" r:id="rId3"/>
    <p:sldId id="267" r:id="rId4"/>
    <p:sldId id="270" r:id="rId5"/>
    <p:sldId id="263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903" autoAdjust="0"/>
    <p:restoredTop sz="95103" autoAdjust="0"/>
  </p:normalViewPr>
  <p:slideViewPr>
    <p:cSldViewPr snapToGrid="0">
      <p:cViewPr>
        <p:scale>
          <a:sx n="70" d="100"/>
          <a:sy n="70" d="100"/>
        </p:scale>
        <p:origin x="-1152" y="-120"/>
      </p:cViewPr>
      <p:guideLst>
        <p:guide orient="horz" pos="2160"/>
        <p:guide pos="381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C00330-12B1-401A-8828-AE55B205FF63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99BF22-E0FF-4091-91DB-90827EA31F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7319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8BC08C9-C583-48A8-BFE1-B49C6878A1D8}" type="slidenum">
              <a:rPr lang="en-US" smtClean="0"/>
              <a:t>5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FACEA-0EA8-4D53-B371-A3B73EBEB405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34B99-107D-4F34-95C1-2EA3B14D6B8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FACEA-0EA8-4D53-B371-A3B73EBEB405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34B99-107D-4F34-95C1-2EA3B14D6B8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FACEA-0EA8-4D53-B371-A3B73EBEB405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34B99-107D-4F34-95C1-2EA3B14D6B8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FACEA-0EA8-4D53-B371-A3B73EBEB405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34B99-107D-4F34-95C1-2EA3B14D6B8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FACEA-0EA8-4D53-B371-A3B73EBEB405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34B99-107D-4F34-95C1-2EA3B14D6B8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FACEA-0EA8-4D53-B371-A3B73EBEB405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34B99-107D-4F34-95C1-2EA3B14D6B8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FACEA-0EA8-4D53-B371-A3B73EBEB405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34B99-107D-4F34-95C1-2EA3B14D6B8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FACEA-0EA8-4D53-B371-A3B73EBEB405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34B99-107D-4F34-95C1-2EA3B14D6B8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FACEA-0EA8-4D53-B371-A3B73EBEB405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34B99-107D-4F34-95C1-2EA3B14D6B8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FACEA-0EA8-4D53-B371-A3B73EBEB405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34B99-107D-4F34-95C1-2EA3B14D6B8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FACEA-0EA8-4D53-B371-A3B73EBEB405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34B99-107D-4F34-95C1-2EA3B14D6B8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5FACEA-0EA8-4D53-B371-A3B73EBEB405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334B99-107D-4F34-95C1-2EA3B14D6B8F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/><Relationship Id="rId3" Type="http://schemas.openxmlformats.org/officeDocument/2006/relationships/image" Target="../media/image11.emf"/><Relationship Id="rId7" Type="http://schemas.openxmlformats.org/officeDocument/2006/relationships/image" Target="../media/image1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emf"/><Relationship Id="rId5" Type="http://schemas.openxmlformats.org/officeDocument/2006/relationships/image" Target="../media/image13.emf"/><Relationship Id="rId4" Type="http://schemas.openxmlformats.org/officeDocument/2006/relationships/image" Target="../media/image12.emf"/><Relationship Id="rId9" Type="http://schemas.openxmlformats.org/officeDocument/2006/relationships/image" Target="../media/image1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4132" t="15884" r="22690" b="7294"/>
          <a:stretch>
            <a:fillRect/>
          </a:stretch>
        </p:blipFill>
        <p:spPr>
          <a:xfrm>
            <a:off x="6900490" y="464134"/>
            <a:ext cx="2829674" cy="193909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l="82949" r="12226" b="78743"/>
          <a:stretch>
            <a:fillRect/>
          </a:stretch>
        </p:blipFill>
        <p:spPr>
          <a:xfrm>
            <a:off x="9844603" y="1602987"/>
            <a:ext cx="327606" cy="74166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l="4964" t="9563" r="21010" b="8776"/>
          <a:stretch>
            <a:fillRect/>
          </a:stretch>
        </p:blipFill>
        <p:spPr>
          <a:xfrm>
            <a:off x="2926353" y="478599"/>
            <a:ext cx="2739316" cy="1871639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/>
          <a:srcRect l="4917" t="6743" r="24318" b="7163"/>
          <a:stretch>
            <a:fillRect/>
          </a:stretch>
        </p:blipFill>
        <p:spPr>
          <a:xfrm>
            <a:off x="2929588" y="3288988"/>
            <a:ext cx="2794649" cy="1875219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2902490" y="2316839"/>
            <a:ext cx="346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091596" y="2316839"/>
            <a:ext cx="346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273534" y="2316839"/>
            <a:ext cx="346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452846" y="2316839"/>
            <a:ext cx="346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656724" y="2316839"/>
            <a:ext cx="346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830409" y="2316839"/>
            <a:ext cx="346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009477" y="2316839"/>
            <a:ext cx="346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190772" y="2316839"/>
            <a:ext cx="346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383436" y="2316839"/>
            <a:ext cx="346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528203" y="2316840"/>
            <a:ext cx="400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720406" y="2316841"/>
            <a:ext cx="3986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4912326" y="2316840"/>
            <a:ext cx="411082" cy="2766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5111928" y="2316840"/>
            <a:ext cx="3993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5299815" y="2323352"/>
            <a:ext cx="4171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</a:p>
        </p:txBody>
      </p:sp>
      <p:sp>
        <p:nvSpPr>
          <p:cNvPr id="23" name="Rectangle 22"/>
          <p:cNvSpPr/>
          <p:nvPr/>
        </p:nvSpPr>
        <p:spPr>
          <a:xfrm>
            <a:off x="3745547" y="2562144"/>
            <a:ext cx="1001739" cy="21289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ek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724350" y="2155619"/>
            <a:ext cx="3830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540970" y="1288722"/>
            <a:ext cx="4721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530412" y="448164"/>
            <a:ext cx="5284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27" name="Rectangle 26"/>
          <p:cNvSpPr/>
          <p:nvPr/>
        </p:nvSpPr>
        <p:spPr>
          <a:xfrm rot="16200000">
            <a:off x="1396301" y="1251025"/>
            <a:ext cx="2068594" cy="24866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ter intake (ml/day/rat)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637780" y="1730900"/>
            <a:ext cx="3765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2543076" y="849335"/>
            <a:ext cx="5024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6910476" y="2350162"/>
            <a:ext cx="3039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7094226" y="2350162"/>
            <a:ext cx="3039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7288039" y="2350162"/>
            <a:ext cx="3039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7491101" y="2350162"/>
            <a:ext cx="3039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7671229" y="2350162"/>
            <a:ext cx="3039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7868664" y="2350162"/>
            <a:ext cx="3039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8071482" y="2350162"/>
            <a:ext cx="3039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8252777" y="2350162"/>
            <a:ext cx="3039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8433566" y="2350162"/>
            <a:ext cx="3039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590774" y="2330372"/>
            <a:ext cx="4364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8808033" y="2330373"/>
            <a:ext cx="3712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8995678" y="2338287"/>
            <a:ext cx="417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9192530" y="2338287"/>
            <a:ext cx="4499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9405770" y="2330372"/>
            <a:ext cx="4066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</a:p>
        </p:txBody>
      </p:sp>
      <p:sp>
        <p:nvSpPr>
          <p:cNvPr id="44" name="Rectangle 43"/>
          <p:cNvSpPr/>
          <p:nvPr/>
        </p:nvSpPr>
        <p:spPr>
          <a:xfrm>
            <a:off x="7829725" y="2598392"/>
            <a:ext cx="1003204" cy="21036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ek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6608229" y="2191872"/>
            <a:ext cx="3762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6592274" y="1295925"/>
            <a:ext cx="4458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6600486" y="403704"/>
            <a:ext cx="5612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</p:txBody>
      </p:sp>
      <p:sp>
        <p:nvSpPr>
          <p:cNvPr id="48" name="Rectangle 47"/>
          <p:cNvSpPr/>
          <p:nvPr/>
        </p:nvSpPr>
        <p:spPr>
          <a:xfrm rot="16200000">
            <a:off x="5443873" y="1264795"/>
            <a:ext cx="2010270" cy="21941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ood intake (ml/day/rat)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6605906" y="1740119"/>
            <a:ext cx="4442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6600486" y="840912"/>
            <a:ext cx="4442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2941513" y="5125776"/>
            <a:ext cx="1728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3149013" y="5125776"/>
            <a:ext cx="1728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3330951" y="5125776"/>
            <a:ext cx="1728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3510263" y="5125776"/>
            <a:ext cx="1728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3678516" y="5125776"/>
            <a:ext cx="1728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3899701" y="5137651"/>
            <a:ext cx="1728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4078770" y="5125776"/>
            <a:ext cx="1728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4283818" y="5125776"/>
            <a:ext cx="1728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4451504" y="5125776"/>
            <a:ext cx="1728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4585299" y="5116677"/>
            <a:ext cx="4090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4803244" y="5116678"/>
            <a:ext cx="3716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4983374" y="5124951"/>
            <a:ext cx="4312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5182465" y="5122589"/>
            <a:ext cx="3972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5380934" y="5122589"/>
            <a:ext cx="3629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</a:p>
        </p:txBody>
      </p:sp>
      <p:sp>
        <p:nvSpPr>
          <p:cNvPr id="65" name="Rectangle 64"/>
          <p:cNvSpPr/>
          <p:nvPr/>
        </p:nvSpPr>
        <p:spPr>
          <a:xfrm>
            <a:off x="3870318" y="5265978"/>
            <a:ext cx="924447" cy="40983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ek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2574809" y="5025344"/>
            <a:ext cx="4806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0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2556290" y="4301066"/>
            <a:ext cx="6360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0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2556290" y="3608245"/>
            <a:ext cx="6360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0</a:t>
            </a:r>
          </a:p>
        </p:txBody>
      </p:sp>
      <p:sp>
        <p:nvSpPr>
          <p:cNvPr id="69" name="Rectangle 68"/>
          <p:cNvSpPr/>
          <p:nvPr/>
        </p:nvSpPr>
        <p:spPr>
          <a:xfrm rot="16200000">
            <a:off x="1463922" y="4122749"/>
            <a:ext cx="1987087" cy="30694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ody </a:t>
            </a:r>
            <a:r>
              <a:rPr lang="en-US" altLang="zh-CN" sz="12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ss</a:t>
            </a:r>
            <a:r>
              <a:rPr lang="en-US" sz="12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mg/rat)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2562280" y="4658971"/>
            <a:ext cx="5034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0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2556441" y="3949599"/>
            <a:ext cx="5034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0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2564888" y="3258845"/>
            <a:ext cx="6360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0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10091128" y="1656888"/>
            <a:ext cx="658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M</a:t>
            </a:r>
          </a:p>
        </p:txBody>
      </p:sp>
      <p:sp>
        <p:nvSpPr>
          <p:cNvPr id="90" name="TextBox 89"/>
          <p:cNvSpPr txBox="1"/>
          <p:nvPr/>
        </p:nvSpPr>
        <p:spPr>
          <a:xfrm>
            <a:off x="10112900" y="1837825"/>
            <a:ext cx="658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CA</a:t>
            </a:r>
          </a:p>
        </p:txBody>
      </p:sp>
      <p:sp>
        <p:nvSpPr>
          <p:cNvPr id="91" name="TextBox 90"/>
          <p:cNvSpPr txBox="1"/>
          <p:nvPr/>
        </p:nvSpPr>
        <p:spPr>
          <a:xfrm>
            <a:off x="10108692" y="2000842"/>
            <a:ext cx="9982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2234963" y="92370"/>
            <a:ext cx="3043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6323259" y="92370"/>
            <a:ext cx="3043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2306593" y="3010416"/>
            <a:ext cx="3043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2312461" y="5872232"/>
            <a:ext cx="85082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Effect of Captopril on DOCA-salt hypertensive rat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ter intake (A), food intake (B), and 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body 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s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. Results were compared by one-way ANOVA and Duncan post hoc test; *p &lt; 0.05, **p &lt; 0.01 and ***p &lt; 0.001 vs. SHAM, #p &lt; 0.05, ##p &lt; 0.01 and ###p &lt; 0.001 vs. DOCA; n = 5.</a:t>
            </a:r>
          </a:p>
        </p:txBody>
      </p:sp>
      <p:cxnSp>
        <p:nvCxnSpPr>
          <p:cNvPr id="3" name="Straight Connector 2"/>
          <p:cNvCxnSpPr/>
          <p:nvPr/>
        </p:nvCxnSpPr>
        <p:spPr>
          <a:xfrm>
            <a:off x="3149013" y="571196"/>
            <a:ext cx="2265619" cy="10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Rectangle 106"/>
          <p:cNvSpPr/>
          <p:nvPr/>
        </p:nvSpPr>
        <p:spPr>
          <a:xfrm>
            <a:off x="3986112" y="355831"/>
            <a:ext cx="4154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sp>
        <p:nvSpPr>
          <p:cNvPr id="108" name="Rectangle 107"/>
          <p:cNvSpPr/>
          <p:nvPr/>
        </p:nvSpPr>
        <p:spPr>
          <a:xfrm>
            <a:off x="4625810" y="4091556"/>
            <a:ext cx="2741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09" name="Rectangle 108"/>
          <p:cNvSpPr/>
          <p:nvPr/>
        </p:nvSpPr>
        <p:spPr>
          <a:xfrm>
            <a:off x="4845804" y="4089884"/>
            <a:ext cx="2741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10" name="Rectangle 109"/>
          <p:cNvSpPr/>
          <p:nvPr/>
        </p:nvSpPr>
        <p:spPr>
          <a:xfrm>
            <a:off x="4992169" y="4119114"/>
            <a:ext cx="34211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</a:p>
        </p:txBody>
      </p:sp>
      <p:sp>
        <p:nvSpPr>
          <p:cNvPr id="112" name="Rectangle 111"/>
          <p:cNvSpPr/>
          <p:nvPr/>
        </p:nvSpPr>
        <p:spPr>
          <a:xfrm>
            <a:off x="5093120" y="3696736"/>
            <a:ext cx="28781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13" name="Rectangle 112"/>
          <p:cNvSpPr/>
          <p:nvPr/>
        </p:nvSpPr>
        <p:spPr>
          <a:xfrm>
            <a:off x="5237027" y="4088098"/>
            <a:ext cx="28781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14" name="Rectangle 113"/>
          <p:cNvSpPr/>
          <p:nvPr/>
        </p:nvSpPr>
        <p:spPr>
          <a:xfrm>
            <a:off x="5263219" y="3678550"/>
            <a:ext cx="28781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15" name="Rectangle 114"/>
          <p:cNvSpPr/>
          <p:nvPr/>
        </p:nvSpPr>
        <p:spPr>
          <a:xfrm>
            <a:off x="5382118" y="4025506"/>
            <a:ext cx="34211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</a:p>
        </p:txBody>
      </p:sp>
      <p:sp>
        <p:nvSpPr>
          <p:cNvPr id="116" name="Rectangle 115"/>
          <p:cNvSpPr/>
          <p:nvPr/>
        </p:nvSpPr>
        <p:spPr>
          <a:xfrm>
            <a:off x="5414632" y="3649051"/>
            <a:ext cx="28781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17" name="TextBox 116"/>
          <p:cNvSpPr txBox="1"/>
          <p:nvPr/>
        </p:nvSpPr>
        <p:spPr>
          <a:xfrm>
            <a:off x="5464777" y="1911426"/>
            <a:ext cx="658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M</a:t>
            </a:r>
          </a:p>
        </p:txBody>
      </p:sp>
      <p:sp>
        <p:nvSpPr>
          <p:cNvPr id="118" name="TextBox 117"/>
          <p:cNvSpPr txBox="1"/>
          <p:nvPr/>
        </p:nvSpPr>
        <p:spPr>
          <a:xfrm>
            <a:off x="5466173" y="634441"/>
            <a:ext cx="658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CA</a:t>
            </a:r>
          </a:p>
        </p:txBody>
      </p:sp>
      <p:sp>
        <p:nvSpPr>
          <p:cNvPr id="119" name="TextBox 118"/>
          <p:cNvSpPr txBox="1"/>
          <p:nvPr/>
        </p:nvSpPr>
        <p:spPr>
          <a:xfrm>
            <a:off x="5464778" y="918013"/>
            <a:ext cx="658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</a:t>
            </a:r>
          </a:p>
        </p:txBody>
      </p:sp>
      <p:sp>
        <p:nvSpPr>
          <p:cNvPr id="120" name="TextBox 119"/>
          <p:cNvSpPr txBox="1"/>
          <p:nvPr/>
        </p:nvSpPr>
        <p:spPr>
          <a:xfrm>
            <a:off x="5523453" y="3484630"/>
            <a:ext cx="658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M</a:t>
            </a:r>
          </a:p>
        </p:txBody>
      </p:sp>
      <p:sp>
        <p:nvSpPr>
          <p:cNvPr id="121" name="TextBox 120"/>
          <p:cNvSpPr txBox="1"/>
          <p:nvPr/>
        </p:nvSpPr>
        <p:spPr>
          <a:xfrm>
            <a:off x="5523453" y="3708049"/>
            <a:ext cx="658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CA</a:t>
            </a:r>
          </a:p>
        </p:txBody>
      </p:sp>
      <p:sp>
        <p:nvSpPr>
          <p:cNvPr id="122" name="TextBox 121"/>
          <p:cNvSpPr txBox="1"/>
          <p:nvPr/>
        </p:nvSpPr>
        <p:spPr>
          <a:xfrm>
            <a:off x="5522444" y="3909498"/>
            <a:ext cx="6590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1002851" y="633620"/>
            <a:ext cx="4399555" cy="3084709"/>
            <a:chOff x="7422386" y="1251135"/>
            <a:chExt cx="4399555" cy="3084709"/>
          </a:xfrm>
        </p:grpSpPr>
        <p:pic>
          <p:nvPicPr>
            <p:cNvPr id="5" name="Picture 2" descr="C:\Users\lzh\Desktop\JAHA Ver2\16s wk0.png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11" t="7458" r="11890" b="12046"/>
            <a:stretch>
              <a:fillRect/>
            </a:stretch>
          </p:blipFill>
          <p:spPr bwMode="auto">
            <a:xfrm>
              <a:off x="8113189" y="1268899"/>
              <a:ext cx="2475906" cy="281223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7" name="Group 15"/>
            <p:cNvGrpSpPr/>
            <p:nvPr/>
          </p:nvGrpSpPr>
          <p:grpSpPr>
            <a:xfrm>
              <a:off x="7422386" y="1278838"/>
              <a:ext cx="4399555" cy="3057006"/>
              <a:chOff x="3622530" y="2537354"/>
              <a:chExt cx="3045283" cy="2138309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5841801" y="2563719"/>
                <a:ext cx="801352" cy="1937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acteroidetes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5841800" y="2689828"/>
                <a:ext cx="801352" cy="1937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irmicutes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5841799" y="2815855"/>
                <a:ext cx="826014" cy="1937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teobacteria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5852527" y="2953214"/>
                <a:ext cx="726258" cy="1937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thers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4183735" y="4477577"/>
                <a:ext cx="513180" cy="19375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AM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4757411" y="4481908"/>
                <a:ext cx="544157" cy="19375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OCA</a:t>
                </a: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5362064" y="4480820"/>
                <a:ext cx="717671" cy="1937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P</a:t>
                </a: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 rot="16200000">
                <a:off x="2838282" y="3355463"/>
                <a:ext cx="1888051" cy="3195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rcentage of community abundance on Phylum level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3931314" y="4345538"/>
                <a:ext cx="220972" cy="1937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3856307" y="3978816"/>
                <a:ext cx="372249" cy="1937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3861164" y="3625563"/>
                <a:ext cx="372249" cy="1937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3868637" y="3254029"/>
                <a:ext cx="372249" cy="1937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3861165" y="2895409"/>
                <a:ext cx="372249" cy="1937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3841910" y="2537354"/>
                <a:ext cx="372249" cy="1937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1027" name="Picture 3" descr="C:\Users\lzh\Desktop\JAHA Ver2\16s wk0.png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246" t="7764" r="9473" b="75812"/>
            <a:stretch>
              <a:fillRect/>
            </a:stretch>
          </p:blipFill>
          <p:spPr bwMode="auto">
            <a:xfrm>
              <a:off x="10580178" y="1251135"/>
              <a:ext cx="134178" cy="98555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29" name="TextBox 28"/>
          <p:cNvSpPr txBox="1"/>
          <p:nvPr/>
        </p:nvSpPr>
        <p:spPr>
          <a:xfrm>
            <a:off x="698427" y="4758957"/>
            <a:ext cx="10692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munity abundanc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one-way ANOVA bar plot (B)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t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lum level in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AM, DOCA and CAP at week 0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028158" y="432733"/>
            <a:ext cx="537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50" name="Picture 2" descr="C:\Users\lzh\Desktop\WHC\Manuscript\Manuscript\manuscript4\For journal of JAHA\JAHA Ver2\RE__For_resubmission_to_JAHA\wk0 phylum barplot.pn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842" t="13460" r="18049" b="74718"/>
          <a:stretch>
            <a:fillRect/>
          </a:stretch>
        </p:blipFill>
        <p:spPr bwMode="auto">
          <a:xfrm>
            <a:off x="10619715" y="670610"/>
            <a:ext cx="200850" cy="5855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C:\Users\lzh\Desktop\WHC\Manuscript\Manuscript\manuscript4\For journal of JAHA\JAHA Ver2\RE__For_resubmission_to_JAHA\wk0 phylum barplot.pn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57" t="16998" r="37304" b="8797"/>
          <a:stretch>
            <a:fillRect/>
          </a:stretch>
        </p:blipFill>
        <p:spPr bwMode="auto">
          <a:xfrm>
            <a:off x="6906289" y="575049"/>
            <a:ext cx="2971042" cy="28885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5699835" y="423680"/>
            <a:ext cx="4195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688000" y="700679"/>
            <a:ext cx="9423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rmicutes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688000" y="1020509"/>
            <a:ext cx="10660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cteroidetes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5688000" y="1374743"/>
            <a:ext cx="12025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obacteria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688000" y="1706718"/>
            <a:ext cx="12025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yanobacteria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5688000" y="2022072"/>
            <a:ext cx="12025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ferribacteres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688245" y="2355532"/>
            <a:ext cx="12025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nericutes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5688000" y="2707098"/>
            <a:ext cx="13485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ccharibacteria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688000" y="3022452"/>
            <a:ext cx="13485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errucomicrobia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6802077" y="3414908"/>
            <a:ext cx="2476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7026901" y="3422460"/>
            <a:ext cx="2476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7224565" y="3420959"/>
            <a:ext cx="3984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7467495" y="3419458"/>
            <a:ext cx="3984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7737584" y="3417957"/>
            <a:ext cx="3984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7962408" y="3425509"/>
            <a:ext cx="3984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8223444" y="3424008"/>
            <a:ext cx="3984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8467991" y="3422459"/>
            <a:ext cx="3984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8706452" y="3423656"/>
            <a:ext cx="3984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8950889" y="3423440"/>
            <a:ext cx="3984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9204449" y="3418564"/>
            <a:ext cx="3984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9432104" y="3418564"/>
            <a:ext cx="3984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9864000" y="702120"/>
            <a:ext cx="9423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9943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9864000" y="1042215"/>
            <a:ext cx="9423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9914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9864000" y="1368552"/>
            <a:ext cx="9423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9732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9864000" y="1706718"/>
            <a:ext cx="9423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9499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9864000" y="2041820"/>
            <a:ext cx="9423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4247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9864530" y="2364619"/>
            <a:ext cx="9423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9388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9864000" y="2736400"/>
            <a:ext cx="9423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863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9864000" y="3077797"/>
            <a:ext cx="9423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6847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7641291" y="3691364"/>
            <a:ext cx="19447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n proportions (%)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0820565" y="651384"/>
            <a:ext cx="6775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AM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10814148" y="840345"/>
            <a:ext cx="6775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CA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0826292" y="1025659"/>
            <a:ext cx="6775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P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630" t="13378" r="16164" b="8988"/>
          <a:stretch>
            <a:fillRect/>
          </a:stretch>
        </p:blipFill>
        <p:spPr>
          <a:xfrm>
            <a:off x="3262363" y="-41499"/>
            <a:ext cx="3786138" cy="600494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109962" y="5857331"/>
            <a:ext cx="520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489233" y="5856762"/>
            <a:ext cx="520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72022" y="5856762"/>
            <a:ext cx="520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243288" y="5856762"/>
            <a:ext cx="520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632981" y="5856762"/>
            <a:ext cx="520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986316" y="5856762"/>
            <a:ext cx="520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5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373960" y="5856762"/>
            <a:ext cx="520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0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750111" y="5856762"/>
            <a:ext cx="520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5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128876" y="5855512"/>
            <a:ext cx="520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0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6499297" y="5855512"/>
            <a:ext cx="520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5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6828247" y="5855512"/>
            <a:ext cx="5208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.0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480677" y="6077919"/>
            <a:ext cx="17972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DA SCORE (log10)</a:t>
            </a: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52" t="7963" r="89259" b="80000"/>
          <a:stretch>
            <a:fillRect/>
          </a:stretch>
        </p:blipFill>
        <p:spPr>
          <a:xfrm>
            <a:off x="7006596" y="453841"/>
            <a:ext cx="436551" cy="850860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7323650" y="642128"/>
            <a:ext cx="7946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CA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7323650" y="787270"/>
            <a:ext cx="7946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M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7323650" y="502786"/>
            <a:ext cx="7946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</a:t>
            </a:r>
          </a:p>
        </p:txBody>
      </p:sp>
      <p:sp>
        <p:nvSpPr>
          <p:cNvPr id="21" name="Rectangle 20"/>
          <p:cNvSpPr/>
          <p:nvPr/>
        </p:nvSpPr>
        <p:spPr>
          <a:xfrm>
            <a:off x="2576192" y="-26399"/>
            <a:ext cx="985619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_Blautia</a:t>
            </a:r>
            <a:endParaRPr 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1385071" y="77162"/>
            <a:ext cx="2312668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_Hydrogenoanaerobacterium</a:t>
            </a:r>
            <a:endParaRPr 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Rectangle 22"/>
          <p:cNvSpPr/>
          <p:nvPr/>
        </p:nvSpPr>
        <p:spPr>
          <a:xfrm>
            <a:off x="2247561" y="212500"/>
            <a:ext cx="1375687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_Tyzzerella_3</a:t>
            </a:r>
          </a:p>
        </p:txBody>
      </p:sp>
      <p:sp>
        <p:nvSpPr>
          <p:cNvPr id="24" name="Rectangle 23"/>
          <p:cNvSpPr/>
          <p:nvPr/>
        </p:nvSpPr>
        <p:spPr>
          <a:xfrm>
            <a:off x="2186605" y="307726"/>
            <a:ext cx="126226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_Aerococcaceae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2338584" y="412347"/>
            <a:ext cx="125085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_Aerococcus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2022427" y="517627"/>
            <a:ext cx="157679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_Verrucomicrobia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1896985" y="734972"/>
            <a:ext cx="168744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_Verrucomicrobiales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1908520" y="839593"/>
            <a:ext cx="166104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_Verrucomicrobiales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2240065" y="957573"/>
            <a:ext cx="144494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_Akkermansia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ectangle 29"/>
          <p:cNvSpPr/>
          <p:nvPr/>
        </p:nvSpPr>
        <p:spPr>
          <a:xfrm>
            <a:off x="2197011" y="1063379"/>
            <a:ext cx="136378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_Lentisphaerae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2451085" y="1171028"/>
            <a:ext cx="119275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_Victivallis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Rectangle 31"/>
          <p:cNvSpPr/>
          <p:nvPr/>
        </p:nvSpPr>
        <p:spPr>
          <a:xfrm>
            <a:off x="2221525" y="1268738"/>
            <a:ext cx="132125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_Lentisphaerae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2319667" y="1391848"/>
            <a:ext cx="131067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_Victivallales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2245099" y="1489558"/>
            <a:ext cx="137157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_Victivallaceae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2106738" y="1605302"/>
            <a:ext cx="155342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_Bifidobacterium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2068964" y="1715711"/>
            <a:ext cx="175434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_Bifidobacteriales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Rectangle 36"/>
          <p:cNvSpPr/>
          <p:nvPr/>
        </p:nvSpPr>
        <p:spPr>
          <a:xfrm>
            <a:off x="1999134" y="1820991"/>
            <a:ext cx="155358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_Bifidobacteriaceae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Rectangle 37"/>
          <p:cNvSpPr/>
          <p:nvPr/>
        </p:nvSpPr>
        <p:spPr>
          <a:xfrm>
            <a:off x="1975709" y="630139"/>
            <a:ext cx="161422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_Verrucomicrobiae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Rectangle 128"/>
          <p:cNvSpPr/>
          <p:nvPr/>
        </p:nvSpPr>
        <p:spPr>
          <a:xfrm>
            <a:off x="1755972" y="1923120"/>
            <a:ext cx="166630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_Gammaproteobacteria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Rectangle 130"/>
          <p:cNvSpPr/>
          <p:nvPr/>
        </p:nvSpPr>
        <p:spPr>
          <a:xfrm>
            <a:off x="2015080" y="2124585"/>
            <a:ext cx="145875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_Enterobacteriales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Rectangle 129"/>
          <p:cNvSpPr/>
          <p:nvPr/>
        </p:nvSpPr>
        <p:spPr>
          <a:xfrm>
            <a:off x="2179634" y="2022812"/>
            <a:ext cx="132947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_Proteobacteria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Rectangle 131"/>
          <p:cNvSpPr/>
          <p:nvPr/>
        </p:nvSpPr>
        <p:spPr>
          <a:xfrm>
            <a:off x="1961488" y="2238551"/>
            <a:ext cx="147912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_Enterobacteriaceae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Rectangle 132"/>
          <p:cNvSpPr/>
          <p:nvPr/>
        </p:nvSpPr>
        <p:spPr>
          <a:xfrm>
            <a:off x="1874015" y="2356989"/>
            <a:ext cx="160154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_Escherichia_Shigella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Rectangle 146"/>
          <p:cNvSpPr/>
          <p:nvPr/>
        </p:nvSpPr>
        <p:spPr>
          <a:xfrm>
            <a:off x="2030478" y="2460032"/>
            <a:ext cx="151361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_Leuconostocaceae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Rectangle 147"/>
          <p:cNvSpPr/>
          <p:nvPr/>
        </p:nvSpPr>
        <p:spPr>
          <a:xfrm>
            <a:off x="2463566" y="2563890"/>
            <a:ext cx="94083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_Weissella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Rectangle 148"/>
          <p:cNvSpPr/>
          <p:nvPr/>
        </p:nvSpPr>
        <p:spPr>
          <a:xfrm>
            <a:off x="1226496" y="2687965"/>
            <a:ext cx="238529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_norank_o_Opitutae_vadinHA64</a:t>
            </a:r>
          </a:p>
        </p:txBody>
      </p:sp>
      <p:sp>
        <p:nvSpPr>
          <p:cNvPr id="49" name="Rectangle 149"/>
          <p:cNvSpPr/>
          <p:nvPr/>
        </p:nvSpPr>
        <p:spPr>
          <a:xfrm>
            <a:off x="1214433" y="2802389"/>
            <a:ext cx="244060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_norank_o_Opitutae_vadinHA64</a:t>
            </a:r>
          </a:p>
        </p:txBody>
      </p:sp>
      <p:sp>
        <p:nvSpPr>
          <p:cNvPr id="50" name="Rectangle 150"/>
          <p:cNvSpPr/>
          <p:nvPr/>
        </p:nvSpPr>
        <p:spPr>
          <a:xfrm>
            <a:off x="2501751" y="2898525"/>
            <a:ext cx="95512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_Opitutae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Rectangle 151"/>
          <p:cNvSpPr/>
          <p:nvPr/>
        </p:nvSpPr>
        <p:spPr>
          <a:xfrm>
            <a:off x="1794493" y="3010612"/>
            <a:ext cx="165483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_Opitutae_vadinHA64</a:t>
            </a:r>
          </a:p>
        </p:txBody>
      </p:sp>
      <p:sp>
        <p:nvSpPr>
          <p:cNvPr id="52" name="Rectangle 152"/>
          <p:cNvSpPr/>
          <p:nvPr/>
        </p:nvSpPr>
        <p:spPr>
          <a:xfrm>
            <a:off x="2023575" y="3106800"/>
            <a:ext cx="148738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_Ruminococcus_2</a:t>
            </a:r>
          </a:p>
        </p:txBody>
      </p:sp>
      <p:sp>
        <p:nvSpPr>
          <p:cNvPr id="53" name="Rectangle 153"/>
          <p:cNvSpPr/>
          <p:nvPr/>
        </p:nvSpPr>
        <p:spPr>
          <a:xfrm>
            <a:off x="1323587" y="3206330"/>
            <a:ext cx="241104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_Eubacterium_nodatum_group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Rectangle 154"/>
          <p:cNvSpPr/>
          <p:nvPr/>
        </p:nvSpPr>
        <p:spPr>
          <a:xfrm>
            <a:off x="1333980" y="3320254"/>
            <a:ext cx="244412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_norank_f_Erysipelotrichaceae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Rectangle 155"/>
          <p:cNvSpPr/>
          <p:nvPr/>
        </p:nvSpPr>
        <p:spPr>
          <a:xfrm>
            <a:off x="2112190" y="3419471"/>
            <a:ext cx="138603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_Micrococcaceae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Rectangle 156"/>
          <p:cNvSpPr/>
          <p:nvPr/>
        </p:nvSpPr>
        <p:spPr>
          <a:xfrm>
            <a:off x="2185195" y="3525409"/>
            <a:ext cx="137822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_Micrococcales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Rectangle 157"/>
          <p:cNvSpPr/>
          <p:nvPr/>
        </p:nvSpPr>
        <p:spPr>
          <a:xfrm>
            <a:off x="1904338" y="3629913"/>
            <a:ext cx="158478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_Campylobacterales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Rectangle 158"/>
          <p:cNvSpPr/>
          <p:nvPr/>
        </p:nvSpPr>
        <p:spPr>
          <a:xfrm>
            <a:off x="1707784" y="3728620"/>
            <a:ext cx="181086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_Epsilonproteobacteria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TextBox 160"/>
          <p:cNvSpPr txBox="1"/>
          <p:nvPr/>
        </p:nvSpPr>
        <p:spPr>
          <a:xfrm>
            <a:off x="2277057" y="3827327"/>
            <a:ext cx="1219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_Helicobacter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TextBox 159"/>
          <p:cNvSpPr txBox="1"/>
          <p:nvPr/>
        </p:nvSpPr>
        <p:spPr>
          <a:xfrm>
            <a:off x="1971260" y="3939062"/>
            <a:ext cx="16367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_Helicobacteraceae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Rectangle 161"/>
          <p:cNvSpPr/>
          <p:nvPr/>
        </p:nvSpPr>
        <p:spPr>
          <a:xfrm>
            <a:off x="2202176" y="4050206"/>
            <a:ext cx="109517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_Mucispirillum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Rectangle 165"/>
          <p:cNvSpPr/>
          <p:nvPr/>
        </p:nvSpPr>
        <p:spPr>
          <a:xfrm>
            <a:off x="2001789" y="4164763"/>
            <a:ext cx="127310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_Deferribacterales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Rectangle 163"/>
          <p:cNvSpPr/>
          <p:nvPr/>
        </p:nvSpPr>
        <p:spPr>
          <a:xfrm>
            <a:off x="2105145" y="4269229"/>
            <a:ext cx="118013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_Deferribacteres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Rectangle 167"/>
          <p:cNvSpPr/>
          <p:nvPr/>
        </p:nvSpPr>
        <p:spPr>
          <a:xfrm>
            <a:off x="1958811" y="4384905"/>
            <a:ext cx="131318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_Staphylococcaceae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Rectangle 164"/>
          <p:cNvSpPr/>
          <p:nvPr/>
        </p:nvSpPr>
        <p:spPr>
          <a:xfrm>
            <a:off x="2109719" y="4493384"/>
            <a:ext cx="116730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_Deferribacteres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Rectangle 166"/>
          <p:cNvSpPr/>
          <p:nvPr/>
        </p:nvSpPr>
        <p:spPr>
          <a:xfrm>
            <a:off x="1941096" y="4612474"/>
            <a:ext cx="134684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_Deferribacteraceae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Rectangle 168"/>
          <p:cNvSpPr/>
          <p:nvPr/>
        </p:nvSpPr>
        <p:spPr>
          <a:xfrm>
            <a:off x="2139559" y="4713526"/>
            <a:ext cx="115288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_Staphylococcus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Rectangle 169"/>
          <p:cNvSpPr/>
          <p:nvPr/>
        </p:nvSpPr>
        <p:spPr>
          <a:xfrm>
            <a:off x="2450154" y="4822809"/>
            <a:ext cx="83227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_Bacillales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Rectangle 172"/>
          <p:cNvSpPr/>
          <p:nvPr/>
        </p:nvSpPr>
        <p:spPr>
          <a:xfrm>
            <a:off x="2287613" y="4918079"/>
            <a:ext cx="98456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_Peptococcus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TextBox 175"/>
          <p:cNvSpPr txBox="1"/>
          <p:nvPr/>
        </p:nvSpPr>
        <p:spPr>
          <a:xfrm>
            <a:off x="1303174" y="5136683"/>
            <a:ext cx="2285999" cy="2446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_ </a:t>
            </a:r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kown_p_Saccharibacteria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TextBox 174"/>
          <p:cNvSpPr txBox="1"/>
          <p:nvPr/>
        </p:nvSpPr>
        <p:spPr>
          <a:xfrm>
            <a:off x="1395978" y="5241141"/>
            <a:ext cx="20888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_Unkown_p_Saccharibacteria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Rectangle 177"/>
          <p:cNvSpPr/>
          <p:nvPr/>
        </p:nvSpPr>
        <p:spPr>
          <a:xfrm>
            <a:off x="1429373" y="5340944"/>
            <a:ext cx="184217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_Candidatus_Saccharimonas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TextBox 179"/>
          <p:cNvSpPr txBox="1"/>
          <p:nvPr/>
        </p:nvSpPr>
        <p:spPr>
          <a:xfrm>
            <a:off x="1369564" y="5564342"/>
            <a:ext cx="22572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_Unkown_p_Saccharibacteria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TextBox 176"/>
          <p:cNvSpPr txBox="1"/>
          <p:nvPr/>
        </p:nvSpPr>
        <p:spPr>
          <a:xfrm>
            <a:off x="2058121" y="5450091"/>
            <a:ext cx="14461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_Saccharibacteria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Rectangle 173"/>
          <p:cNvSpPr/>
          <p:nvPr/>
        </p:nvSpPr>
        <p:spPr>
          <a:xfrm>
            <a:off x="1378711" y="5043739"/>
            <a:ext cx="189827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_Ruminococcaceae_UCG_007</a:t>
            </a:r>
          </a:p>
        </p:txBody>
      </p:sp>
      <p:sp>
        <p:nvSpPr>
          <p:cNvPr id="76" name="TextBox 191"/>
          <p:cNvSpPr txBox="1"/>
          <p:nvPr/>
        </p:nvSpPr>
        <p:spPr>
          <a:xfrm>
            <a:off x="109182" y="6393128"/>
            <a:ext cx="120828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Phylogenetic distribution of gut microbiota in SHAM, DOCA and CAP at week 14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or bacteria with LDA scores of 2 or greater in bacterial communities. 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74"/>
          <p:cNvGrpSpPr/>
          <p:nvPr/>
        </p:nvGrpSpPr>
        <p:grpSpPr>
          <a:xfrm>
            <a:off x="2040614" y="458704"/>
            <a:ext cx="4165338" cy="3400191"/>
            <a:chOff x="1425516" y="-1584612"/>
            <a:chExt cx="4165338" cy="3400191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2"/>
            <a:srcRect l="5488" t="30999" r="15069" b="6192"/>
            <a:stretch>
              <a:fillRect/>
            </a:stretch>
          </p:blipFill>
          <p:spPr>
            <a:xfrm>
              <a:off x="2293204" y="-1513999"/>
              <a:ext cx="3297650" cy="2838533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3"/>
            <a:srcRect l="68670" t="1823" r="25473" b="82333"/>
            <a:stretch>
              <a:fillRect/>
            </a:stretch>
          </p:blipFill>
          <p:spPr>
            <a:xfrm>
              <a:off x="2291073" y="-1584612"/>
              <a:ext cx="359014" cy="1137189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2393459" y="1330566"/>
              <a:ext cx="274734" cy="284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783093" y="1318571"/>
              <a:ext cx="331884" cy="2833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174219" y="1319684"/>
              <a:ext cx="372638" cy="2833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597141" y="1320529"/>
              <a:ext cx="390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996868" y="1321139"/>
              <a:ext cx="3807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355410" y="1323109"/>
              <a:ext cx="3983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744232" y="1319587"/>
              <a:ext cx="4745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134634" y="1324767"/>
              <a:ext cx="4092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554845" y="1538580"/>
              <a:ext cx="722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eek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887181" y="1137302"/>
              <a:ext cx="4996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885190" y="614439"/>
              <a:ext cx="4996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0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885190" y="96442"/>
              <a:ext cx="4996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0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885190" y="-980043"/>
              <a:ext cx="4996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0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885190" y="-1507967"/>
              <a:ext cx="4996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242063" y="-284393"/>
              <a:ext cx="282857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ystolic blood pressure </a:t>
              </a:r>
            </a:p>
            <a:p>
              <a:pPr algn="ctr"/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mmHg)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885190" y="863582"/>
              <a:ext cx="4996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0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885190" y="349503"/>
              <a:ext cx="4996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885190" y="-192059"/>
              <a:ext cx="4996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0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885190" y="-440550"/>
              <a:ext cx="4996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0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885190" y="-700916"/>
              <a:ext cx="4996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0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883035" y="-1250281"/>
              <a:ext cx="4996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90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506983" y="-1555233"/>
              <a:ext cx="9143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AM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495905" y="-1000718"/>
              <a:ext cx="13233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AM→SHAM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495905" y="-739823"/>
              <a:ext cx="13338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OCA→SHAM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503257" y="-1278234"/>
              <a:ext cx="10004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OCA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3" name="Straight Arrow Connector 68"/>
            <p:cNvCxnSpPr/>
            <p:nvPr/>
          </p:nvCxnSpPr>
          <p:spPr>
            <a:xfrm flipH="1" flipV="1">
              <a:off x="4108787" y="603687"/>
              <a:ext cx="2449" cy="208766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/>
            <p:cNvSpPr txBox="1"/>
            <p:nvPr/>
          </p:nvSpPr>
          <p:spPr>
            <a:xfrm>
              <a:off x="3313997" y="808418"/>
              <a:ext cx="19636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tibiotics 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eatment</a:t>
              </a:r>
            </a:p>
          </p:txBody>
        </p:sp>
      </p:grpSp>
      <p:sp>
        <p:nvSpPr>
          <p:cNvPr id="35" name="Rectangle 3"/>
          <p:cNvSpPr/>
          <p:nvPr/>
        </p:nvSpPr>
        <p:spPr>
          <a:xfrm>
            <a:off x="5308530" y="614826"/>
            <a:ext cx="3626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36" name="Rectangle 71"/>
          <p:cNvSpPr/>
          <p:nvPr/>
        </p:nvSpPr>
        <p:spPr>
          <a:xfrm>
            <a:off x="3395411" y="1976095"/>
            <a:ext cx="24397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72"/>
          <p:cNvSpPr/>
          <p:nvPr/>
        </p:nvSpPr>
        <p:spPr>
          <a:xfrm>
            <a:off x="4169943" y="1553170"/>
            <a:ext cx="30328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73"/>
          <p:cNvSpPr/>
          <p:nvPr/>
        </p:nvSpPr>
        <p:spPr>
          <a:xfrm>
            <a:off x="3810341" y="1733310"/>
            <a:ext cx="24397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75"/>
          <p:cNvSpPr/>
          <p:nvPr/>
        </p:nvSpPr>
        <p:spPr>
          <a:xfrm>
            <a:off x="4574331" y="1330672"/>
            <a:ext cx="30328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76"/>
          <p:cNvSpPr/>
          <p:nvPr/>
        </p:nvSpPr>
        <p:spPr>
          <a:xfrm>
            <a:off x="4989471" y="1227832"/>
            <a:ext cx="24397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tangle 78"/>
          <p:cNvSpPr/>
          <p:nvPr/>
        </p:nvSpPr>
        <p:spPr>
          <a:xfrm>
            <a:off x="5726144" y="513022"/>
            <a:ext cx="3626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42" name="Rectangle 79"/>
          <p:cNvSpPr/>
          <p:nvPr/>
        </p:nvSpPr>
        <p:spPr>
          <a:xfrm>
            <a:off x="5806171" y="1668318"/>
            <a:ext cx="24397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矩形 42"/>
          <p:cNvSpPr/>
          <p:nvPr/>
        </p:nvSpPr>
        <p:spPr>
          <a:xfrm>
            <a:off x="1526331" y="4021268"/>
            <a:ext cx="8722192" cy="6451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 Effect of gut microbiota of DOCA-salt hypertensive rat on blood pressure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of systolic blood pressure of rats in SHAM, DOCA,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AM with SHAM microbiota after antibiotics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ment (SHAM→SHAM), and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AM with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CA microbiota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 antibiotics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ment (DOCA→SHAM)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*p &lt; 0.05, **p &lt; 0.01 and ***p &lt; 0.001 vs. SHAM; n = 4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l="10321" t="6029" b="20765"/>
          <a:stretch>
            <a:fillRect/>
          </a:stretch>
        </p:blipFill>
        <p:spPr>
          <a:xfrm>
            <a:off x="1110090" y="368443"/>
            <a:ext cx="2859457" cy="2569922"/>
          </a:xfrm>
          <a:prstGeom prst="rect">
            <a:avLst/>
          </a:prstGeom>
        </p:spPr>
      </p:pic>
      <p:sp>
        <p:nvSpPr>
          <p:cNvPr id="4" name="TextBox 71"/>
          <p:cNvSpPr txBox="1"/>
          <p:nvPr/>
        </p:nvSpPr>
        <p:spPr>
          <a:xfrm>
            <a:off x="552238" y="29087"/>
            <a:ext cx="3368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grpSp>
        <p:nvGrpSpPr>
          <p:cNvPr id="5" name="Group 9"/>
          <p:cNvGrpSpPr/>
          <p:nvPr/>
        </p:nvGrpSpPr>
        <p:grpSpPr>
          <a:xfrm>
            <a:off x="379106" y="353964"/>
            <a:ext cx="3856846" cy="2823334"/>
            <a:chOff x="-105074" y="1673044"/>
            <a:chExt cx="2481112" cy="2153975"/>
          </a:xfrm>
        </p:grpSpPr>
        <p:sp>
          <p:nvSpPr>
            <p:cNvPr id="6" name="TextBox 76"/>
            <p:cNvSpPr txBox="1"/>
            <p:nvPr/>
          </p:nvSpPr>
          <p:spPr>
            <a:xfrm>
              <a:off x="232500" y="3506826"/>
              <a:ext cx="191242" cy="2113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7" name="TextBox 77"/>
            <p:cNvSpPr txBox="1"/>
            <p:nvPr/>
          </p:nvSpPr>
          <p:spPr>
            <a:xfrm>
              <a:off x="137822" y="2592955"/>
              <a:ext cx="319821" cy="2113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sp>
          <p:nvSpPr>
            <p:cNvPr id="8" name="TextBox 78"/>
            <p:cNvSpPr txBox="1"/>
            <p:nvPr/>
          </p:nvSpPr>
          <p:spPr>
            <a:xfrm>
              <a:off x="143652" y="2142889"/>
              <a:ext cx="308804" cy="2113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0</a:t>
              </a:r>
            </a:p>
          </p:txBody>
        </p:sp>
        <p:sp>
          <p:nvSpPr>
            <p:cNvPr id="9" name="TextBox 79"/>
            <p:cNvSpPr txBox="1"/>
            <p:nvPr/>
          </p:nvSpPr>
          <p:spPr>
            <a:xfrm>
              <a:off x="142956" y="1673044"/>
              <a:ext cx="314687" cy="2113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</a:p>
          </p:txBody>
        </p:sp>
        <p:sp>
          <p:nvSpPr>
            <p:cNvPr id="10" name="TextBox 81"/>
            <p:cNvSpPr txBox="1"/>
            <p:nvPr/>
          </p:nvSpPr>
          <p:spPr>
            <a:xfrm>
              <a:off x="1753507" y="1979110"/>
              <a:ext cx="443218" cy="2113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AM</a:t>
              </a:r>
            </a:p>
          </p:txBody>
        </p:sp>
        <p:sp>
          <p:nvSpPr>
            <p:cNvPr id="11" name="TextBox 82"/>
            <p:cNvSpPr txBox="1"/>
            <p:nvPr/>
          </p:nvSpPr>
          <p:spPr>
            <a:xfrm>
              <a:off x="1763863" y="2133807"/>
              <a:ext cx="437571" cy="2113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OCA</a:t>
              </a:r>
            </a:p>
          </p:txBody>
        </p:sp>
        <p:sp>
          <p:nvSpPr>
            <p:cNvPr id="12" name="TextBox 83"/>
            <p:cNvSpPr txBox="1"/>
            <p:nvPr/>
          </p:nvSpPr>
          <p:spPr>
            <a:xfrm>
              <a:off x="1768785" y="2282225"/>
              <a:ext cx="607253" cy="2113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P</a:t>
              </a:r>
            </a:p>
          </p:txBody>
        </p:sp>
        <p:sp>
          <p:nvSpPr>
            <p:cNvPr id="13" name="TextBox 84"/>
            <p:cNvSpPr txBox="1"/>
            <p:nvPr/>
          </p:nvSpPr>
          <p:spPr>
            <a:xfrm rot="16200000">
              <a:off x="-732651" y="2533408"/>
              <a:ext cx="1552143" cy="2969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centration per gram feces (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M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/g)</a:t>
              </a:r>
            </a:p>
          </p:txBody>
        </p:sp>
        <p:pic>
          <p:nvPicPr>
            <p:cNvPr id="15" name="Picture 86"/>
            <p:cNvPicPr>
              <a:picLocks noChangeAspect="1"/>
            </p:cNvPicPr>
            <p:nvPr/>
          </p:nvPicPr>
          <p:blipFill rotWithShape="1">
            <a:blip r:embed="rId4"/>
            <a:srcRect l="75197" t="7361" r="16750" b="68555"/>
            <a:stretch>
              <a:fillRect/>
            </a:stretch>
          </p:blipFill>
          <p:spPr>
            <a:xfrm>
              <a:off x="1592741" y="1992437"/>
              <a:ext cx="240199" cy="475394"/>
            </a:xfrm>
            <a:prstGeom prst="rect">
              <a:avLst/>
            </a:prstGeom>
          </p:spPr>
        </p:pic>
        <p:sp>
          <p:nvSpPr>
            <p:cNvPr id="16" name="TextBox 87"/>
            <p:cNvSpPr txBox="1"/>
            <p:nvPr/>
          </p:nvSpPr>
          <p:spPr>
            <a:xfrm>
              <a:off x="489815" y="3615691"/>
              <a:ext cx="502716" cy="2113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etate</a:t>
              </a:r>
            </a:p>
          </p:txBody>
        </p:sp>
        <p:sp>
          <p:nvSpPr>
            <p:cNvPr id="17" name="TextBox 88"/>
            <p:cNvSpPr txBox="1"/>
            <p:nvPr/>
          </p:nvSpPr>
          <p:spPr>
            <a:xfrm>
              <a:off x="1004079" y="3614189"/>
              <a:ext cx="652730" cy="2113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pionate</a:t>
              </a:r>
            </a:p>
          </p:txBody>
        </p:sp>
        <p:sp>
          <p:nvSpPr>
            <p:cNvPr id="18" name="TextBox 89"/>
            <p:cNvSpPr txBox="1"/>
            <p:nvPr/>
          </p:nvSpPr>
          <p:spPr>
            <a:xfrm>
              <a:off x="1659813" y="3614189"/>
              <a:ext cx="527449" cy="2113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utyrate</a:t>
              </a:r>
            </a:p>
          </p:txBody>
        </p:sp>
        <p:sp>
          <p:nvSpPr>
            <p:cNvPr id="126" name="TextBox 77"/>
            <p:cNvSpPr txBox="1"/>
            <p:nvPr/>
          </p:nvSpPr>
          <p:spPr>
            <a:xfrm>
              <a:off x="184028" y="3058877"/>
              <a:ext cx="281121" cy="2113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</a:p>
          </p:txBody>
        </p:sp>
      </p:grpSp>
      <p:pic>
        <p:nvPicPr>
          <p:cNvPr id="29" name="Picture 5"/>
          <p:cNvPicPr>
            <a:picLocks noChangeAspect="1"/>
          </p:cNvPicPr>
          <p:nvPr/>
        </p:nvPicPr>
        <p:blipFill rotWithShape="1">
          <a:blip r:embed="rId5"/>
          <a:srcRect l="18927" t="8842" b="28323"/>
          <a:stretch>
            <a:fillRect/>
          </a:stretch>
        </p:blipFill>
        <p:spPr>
          <a:xfrm>
            <a:off x="5126529" y="368442"/>
            <a:ext cx="2037525" cy="2593113"/>
          </a:xfrm>
          <a:prstGeom prst="rect">
            <a:avLst/>
          </a:prstGeom>
        </p:spPr>
      </p:pic>
      <p:sp>
        <p:nvSpPr>
          <p:cNvPr id="33" name="TextBox 25"/>
          <p:cNvSpPr txBox="1"/>
          <p:nvPr/>
        </p:nvSpPr>
        <p:spPr>
          <a:xfrm>
            <a:off x="4654016" y="2693569"/>
            <a:ext cx="6044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0</a:t>
            </a:r>
          </a:p>
        </p:txBody>
      </p:sp>
      <p:sp>
        <p:nvSpPr>
          <p:cNvPr id="34" name="TextBox 26"/>
          <p:cNvSpPr txBox="1"/>
          <p:nvPr/>
        </p:nvSpPr>
        <p:spPr>
          <a:xfrm>
            <a:off x="4643447" y="1884201"/>
            <a:ext cx="657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5</a:t>
            </a:r>
          </a:p>
        </p:txBody>
      </p:sp>
      <p:sp>
        <p:nvSpPr>
          <p:cNvPr id="35" name="TextBox 27"/>
          <p:cNvSpPr txBox="1"/>
          <p:nvPr/>
        </p:nvSpPr>
        <p:spPr>
          <a:xfrm>
            <a:off x="4646744" y="1052611"/>
            <a:ext cx="575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10</a:t>
            </a:r>
          </a:p>
        </p:txBody>
      </p:sp>
      <p:sp>
        <p:nvSpPr>
          <p:cNvPr id="36" name="TextBox 28"/>
          <p:cNvSpPr txBox="1"/>
          <p:nvPr/>
        </p:nvSpPr>
        <p:spPr>
          <a:xfrm>
            <a:off x="4633088" y="223024"/>
            <a:ext cx="5887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15</a:t>
            </a:r>
          </a:p>
        </p:txBody>
      </p:sp>
      <p:sp>
        <p:nvSpPr>
          <p:cNvPr id="37" name="TextBox 51"/>
          <p:cNvSpPr txBox="1"/>
          <p:nvPr/>
        </p:nvSpPr>
        <p:spPr>
          <a:xfrm rot="16200000">
            <a:off x="3438597" y="1360132"/>
            <a:ext cx="20525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yptophan degradation 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% of total readings)</a:t>
            </a:r>
          </a:p>
        </p:txBody>
      </p:sp>
      <p:sp>
        <p:nvSpPr>
          <p:cNvPr id="38" name="TextBox 56"/>
          <p:cNvSpPr txBox="1"/>
          <p:nvPr/>
        </p:nvSpPr>
        <p:spPr>
          <a:xfrm>
            <a:off x="5182106" y="2873875"/>
            <a:ext cx="6854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HAM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57"/>
          <p:cNvSpPr txBox="1"/>
          <p:nvPr/>
        </p:nvSpPr>
        <p:spPr>
          <a:xfrm>
            <a:off x="5846486" y="2873875"/>
            <a:ext cx="6570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CA</a:t>
            </a:r>
          </a:p>
        </p:txBody>
      </p:sp>
      <p:sp>
        <p:nvSpPr>
          <p:cNvPr id="40" name="TextBox 58"/>
          <p:cNvSpPr txBox="1"/>
          <p:nvPr/>
        </p:nvSpPr>
        <p:spPr>
          <a:xfrm>
            <a:off x="6556366" y="2864094"/>
            <a:ext cx="5366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CAP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72"/>
          <p:cNvSpPr txBox="1"/>
          <p:nvPr/>
        </p:nvSpPr>
        <p:spPr>
          <a:xfrm>
            <a:off x="4262860" y="30802"/>
            <a:ext cx="2903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pic>
        <p:nvPicPr>
          <p:cNvPr id="42" name="Picture 3"/>
          <p:cNvPicPr>
            <a:picLocks noChangeAspect="1"/>
          </p:cNvPicPr>
          <p:nvPr/>
        </p:nvPicPr>
        <p:blipFill rotWithShape="1">
          <a:blip r:embed="rId6"/>
          <a:srcRect l="14173" t="5791" b="22601"/>
          <a:stretch>
            <a:fillRect/>
          </a:stretch>
        </p:blipFill>
        <p:spPr>
          <a:xfrm>
            <a:off x="8314593" y="205726"/>
            <a:ext cx="2182719" cy="2733909"/>
          </a:xfrm>
          <a:prstGeom prst="rect">
            <a:avLst/>
          </a:prstGeom>
        </p:spPr>
      </p:pic>
      <p:sp>
        <p:nvSpPr>
          <p:cNvPr id="47" name="TextBox 29"/>
          <p:cNvSpPr txBox="1"/>
          <p:nvPr/>
        </p:nvSpPr>
        <p:spPr>
          <a:xfrm>
            <a:off x="7988081" y="2047057"/>
            <a:ext cx="4058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</a:p>
        </p:txBody>
      </p:sp>
      <p:sp>
        <p:nvSpPr>
          <p:cNvPr id="48" name="TextBox 30"/>
          <p:cNvSpPr txBox="1"/>
          <p:nvPr/>
        </p:nvSpPr>
        <p:spPr>
          <a:xfrm>
            <a:off x="7996548" y="2661365"/>
            <a:ext cx="444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</a:p>
        </p:txBody>
      </p:sp>
      <p:sp>
        <p:nvSpPr>
          <p:cNvPr id="49" name="TextBox 31"/>
          <p:cNvSpPr txBox="1"/>
          <p:nvPr/>
        </p:nvSpPr>
        <p:spPr>
          <a:xfrm>
            <a:off x="7988082" y="1424482"/>
            <a:ext cx="4528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</a:p>
        </p:txBody>
      </p:sp>
      <p:sp>
        <p:nvSpPr>
          <p:cNvPr id="50" name="TextBox 32"/>
          <p:cNvSpPr txBox="1"/>
          <p:nvPr/>
        </p:nvSpPr>
        <p:spPr>
          <a:xfrm>
            <a:off x="7987404" y="821922"/>
            <a:ext cx="4444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</a:p>
        </p:txBody>
      </p:sp>
      <p:sp>
        <p:nvSpPr>
          <p:cNvPr id="51" name="TextBox 33"/>
          <p:cNvSpPr txBox="1"/>
          <p:nvPr/>
        </p:nvSpPr>
        <p:spPr>
          <a:xfrm>
            <a:off x="7987403" y="191249"/>
            <a:ext cx="4705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</a:p>
        </p:txBody>
      </p:sp>
      <p:sp>
        <p:nvSpPr>
          <p:cNvPr id="52" name="TextBox 52"/>
          <p:cNvSpPr txBox="1"/>
          <p:nvPr/>
        </p:nvSpPr>
        <p:spPr>
          <a:xfrm rot="16200000">
            <a:off x="6697902" y="1252304"/>
            <a:ext cx="21403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yptophan biosynthesis 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% of total readings)</a:t>
            </a:r>
          </a:p>
        </p:txBody>
      </p:sp>
      <p:sp>
        <p:nvSpPr>
          <p:cNvPr id="53" name="TextBox 59"/>
          <p:cNvSpPr txBox="1"/>
          <p:nvPr/>
        </p:nvSpPr>
        <p:spPr>
          <a:xfrm>
            <a:off x="8402374" y="2857766"/>
            <a:ext cx="6699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HAM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Box 60"/>
          <p:cNvSpPr txBox="1"/>
          <p:nvPr/>
        </p:nvSpPr>
        <p:spPr>
          <a:xfrm>
            <a:off x="9114676" y="2849596"/>
            <a:ext cx="708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CA</a:t>
            </a:r>
          </a:p>
        </p:txBody>
      </p:sp>
      <p:sp>
        <p:nvSpPr>
          <p:cNvPr id="55" name="TextBox 61"/>
          <p:cNvSpPr txBox="1"/>
          <p:nvPr/>
        </p:nvSpPr>
        <p:spPr>
          <a:xfrm>
            <a:off x="9849386" y="2842985"/>
            <a:ext cx="5302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CAP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TextBox 90"/>
          <p:cNvSpPr txBox="1"/>
          <p:nvPr/>
        </p:nvSpPr>
        <p:spPr>
          <a:xfrm>
            <a:off x="7532868" y="29087"/>
            <a:ext cx="332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pic>
        <p:nvPicPr>
          <p:cNvPr id="57" name="Picture 1"/>
          <p:cNvPicPr>
            <a:picLocks noChangeAspect="1"/>
          </p:cNvPicPr>
          <p:nvPr/>
        </p:nvPicPr>
        <p:blipFill rotWithShape="1">
          <a:blip r:embed="rId7"/>
          <a:srcRect l="18441" t="11187" b="26851"/>
          <a:stretch>
            <a:fillRect/>
          </a:stretch>
        </p:blipFill>
        <p:spPr>
          <a:xfrm>
            <a:off x="1423856" y="3341482"/>
            <a:ext cx="2059412" cy="2562768"/>
          </a:xfrm>
          <a:prstGeom prst="rect">
            <a:avLst/>
          </a:prstGeom>
        </p:spPr>
      </p:pic>
      <p:sp>
        <p:nvSpPr>
          <p:cNvPr id="58" name="TextBox 44"/>
          <p:cNvSpPr txBox="1"/>
          <p:nvPr/>
        </p:nvSpPr>
        <p:spPr>
          <a:xfrm>
            <a:off x="986011" y="5665884"/>
            <a:ext cx="5229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</a:t>
            </a:r>
          </a:p>
        </p:txBody>
      </p:sp>
      <p:sp>
        <p:nvSpPr>
          <p:cNvPr id="59" name="TextBox 45"/>
          <p:cNvSpPr txBox="1"/>
          <p:nvPr/>
        </p:nvSpPr>
        <p:spPr>
          <a:xfrm>
            <a:off x="988697" y="4918920"/>
            <a:ext cx="5229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5</a:t>
            </a:r>
          </a:p>
        </p:txBody>
      </p:sp>
      <p:sp>
        <p:nvSpPr>
          <p:cNvPr id="60" name="TextBox 46"/>
          <p:cNvSpPr txBox="1"/>
          <p:nvPr/>
        </p:nvSpPr>
        <p:spPr>
          <a:xfrm>
            <a:off x="985744" y="4164063"/>
            <a:ext cx="5315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0</a:t>
            </a:r>
          </a:p>
        </p:txBody>
      </p:sp>
      <p:sp>
        <p:nvSpPr>
          <p:cNvPr id="61" name="TextBox 47"/>
          <p:cNvSpPr txBox="1"/>
          <p:nvPr/>
        </p:nvSpPr>
        <p:spPr>
          <a:xfrm>
            <a:off x="973218" y="3409206"/>
            <a:ext cx="5229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5</a:t>
            </a:r>
          </a:p>
        </p:txBody>
      </p:sp>
      <p:sp>
        <p:nvSpPr>
          <p:cNvPr id="65" name="TextBox 55"/>
          <p:cNvSpPr txBox="1"/>
          <p:nvPr/>
        </p:nvSpPr>
        <p:spPr>
          <a:xfrm rot="16200000">
            <a:off x="-157907" y="4413051"/>
            <a:ext cx="19153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utamate degradation 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% of total readings)</a:t>
            </a:r>
          </a:p>
        </p:txBody>
      </p:sp>
      <p:sp>
        <p:nvSpPr>
          <p:cNvPr id="66" name="TextBox 68"/>
          <p:cNvSpPr txBox="1"/>
          <p:nvPr/>
        </p:nvSpPr>
        <p:spPr>
          <a:xfrm>
            <a:off x="1456845" y="5851958"/>
            <a:ext cx="6515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M</a:t>
            </a:r>
          </a:p>
        </p:txBody>
      </p:sp>
      <p:sp>
        <p:nvSpPr>
          <p:cNvPr id="67" name="TextBox 69"/>
          <p:cNvSpPr txBox="1"/>
          <p:nvPr/>
        </p:nvSpPr>
        <p:spPr>
          <a:xfrm>
            <a:off x="2139257" y="5846371"/>
            <a:ext cx="7529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CA</a:t>
            </a:r>
          </a:p>
        </p:txBody>
      </p:sp>
      <p:sp>
        <p:nvSpPr>
          <p:cNvPr id="68" name="TextBox 75"/>
          <p:cNvSpPr txBox="1"/>
          <p:nvPr/>
        </p:nvSpPr>
        <p:spPr>
          <a:xfrm>
            <a:off x="568939" y="3183313"/>
            <a:ext cx="276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71" name="TextBox 58"/>
          <p:cNvSpPr txBox="1"/>
          <p:nvPr/>
        </p:nvSpPr>
        <p:spPr>
          <a:xfrm>
            <a:off x="2846851" y="5846371"/>
            <a:ext cx="5366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CAP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2" name="Picture 6"/>
          <p:cNvPicPr>
            <a:picLocks noChangeAspect="1"/>
          </p:cNvPicPr>
          <p:nvPr/>
        </p:nvPicPr>
        <p:blipFill rotWithShape="1">
          <a:blip r:embed="rId8"/>
          <a:srcRect l="19443" t="6299" b="29523"/>
          <a:stretch>
            <a:fillRect/>
          </a:stretch>
        </p:blipFill>
        <p:spPr>
          <a:xfrm>
            <a:off x="5175491" y="3393253"/>
            <a:ext cx="2131185" cy="2498109"/>
          </a:xfrm>
          <a:prstGeom prst="rect">
            <a:avLst/>
          </a:prstGeom>
        </p:spPr>
      </p:pic>
      <p:sp>
        <p:nvSpPr>
          <p:cNvPr id="76" name="TextBox 34"/>
          <p:cNvSpPr txBox="1"/>
          <p:nvPr/>
        </p:nvSpPr>
        <p:spPr>
          <a:xfrm>
            <a:off x="4677233" y="5201902"/>
            <a:ext cx="587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5</a:t>
            </a:r>
          </a:p>
        </p:txBody>
      </p:sp>
      <p:sp>
        <p:nvSpPr>
          <p:cNvPr id="77" name="TextBox 35"/>
          <p:cNvSpPr txBox="1"/>
          <p:nvPr/>
        </p:nvSpPr>
        <p:spPr>
          <a:xfrm>
            <a:off x="4669631" y="4742238"/>
            <a:ext cx="6055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10</a:t>
            </a:r>
          </a:p>
        </p:txBody>
      </p:sp>
      <p:sp>
        <p:nvSpPr>
          <p:cNvPr id="78" name="TextBox 36"/>
          <p:cNvSpPr txBox="1"/>
          <p:nvPr/>
        </p:nvSpPr>
        <p:spPr>
          <a:xfrm>
            <a:off x="4679389" y="4262648"/>
            <a:ext cx="5990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15</a:t>
            </a:r>
          </a:p>
        </p:txBody>
      </p:sp>
      <p:sp>
        <p:nvSpPr>
          <p:cNvPr id="79" name="TextBox 37"/>
          <p:cNvSpPr txBox="1"/>
          <p:nvPr/>
        </p:nvSpPr>
        <p:spPr>
          <a:xfrm>
            <a:off x="4676480" y="3804530"/>
            <a:ext cx="639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20</a:t>
            </a:r>
          </a:p>
        </p:txBody>
      </p:sp>
      <p:sp>
        <p:nvSpPr>
          <p:cNvPr id="80" name="TextBox 38"/>
          <p:cNvSpPr txBox="1"/>
          <p:nvPr/>
        </p:nvSpPr>
        <p:spPr>
          <a:xfrm>
            <a:off x="4687444" y="3373523"/>
            <a:ext cx="609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25</a:t>
            </a:r>
          </a:p>
        </p:txBody>
      </p:sp>
      <p:sp>
        <p:nvSpPr>
          <p:cNvPr id="81" name="TextBox 53"/>
          <p:cNvSpPr txBox="1"/>
          <p:nvPr/>
        </p:nvSpPr>
        <p:spPr>
          <a:xfrm rot="16200000">
            <a:off x="3567541" y="4416300"/>
            <a:ext cx="18322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ginine degradation (% of total readings)</a:t>
            </a:r>
          </a:p>
        </p:txBody>
      </p:sp>
      <p:sp>
        <p:nvSpPr>
          <p:cNvPr id="82" name="TextBox 62"/>
          <p:cNvSpPr txBox="1"/>
          <p:nvPr/>
        </p:nvSpPr>
        <p:spPr>
          <a:xfrm>
            <a:off x="5269971" y="5866118"/>
            <a:ext cx="7817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HAM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TextBox 63"/>
          <p:cNvSpPr txBox="1"/>
          <p:nvPr/>
        </p:nvSpPr>
        <p:spPr>
          <a:xfrm>
            <a:off x="5956614" y="5868248"/>
            <a:ext cx="6569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CA</a:t>
            </a:r>
          </a:p>
        </p:txBody>
      </p:sp>
      <p:sp>
        <p:nvSpPr>
          <p:cNvPr id="84" name="TextBox 64"/>
          <p:cNvSpPr txBox="1"/>
          <p:nvPr/>
        </p:nvSpPr>
        <p:spPr>
          <a:xfrm>
            <a:off x="6658950" y="5854787"/>
            <a:ext cx="5820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CAP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TextBox 73"/>
          <p:cNvSpPr txBox="1"/>
          <p:nvPr/>
        </p:nvSpPr>
        <p:spPr>
          <a:xfrm>
            <a:off x="4268374" y="3186303"/>
            <a:ext cx="3538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86" name="TextBox 80"/>
          <p:cNvSpPr txBox="1"/>
          <p:nvPr/>
        </p:nvSpPr>
        <p:spPr>
          <a:xfrm>
            <a:off x="4691218" y="5649499"/>
            <a:ext cx="5937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0</a:t>
            </a:r>
          </a:p>
        </p:txBody>
      </p:sp>
      <p:pic>
        <p:nvPicPr>
          <p:cNvPr id="88" name="Picture 7"/>
          <p:cNvPicPr>
            <a:picLocks noChangeAspect="1"/>
          </p:cNvPicPr>
          <p:nvPr/>
        </p:nvPicPr>
        <p:blipFill rotWithShape="1">
          <a:blip r:embed="rId9"/>
          <a:srcRect l="14705" t="6228" b="22763"/>
          <a:stretch>
            <a:fillRect/>
          </a:stretch>
        </p:blipFill>
        <p:spPr>
          <a:xfrm>
            <a:off x="8551000" y="3307735"/>
            <a:ext cx="2101973" cy="2630649"/>
          </a:xfrm>
          <a:prstGeom prst="rect">
            <a:avLst/>
          </a:prstGeom>
        </p:spPr>
      </p:pic>
      <p:sp>
        <p:nvSpPr>
          <p:cNvPr id="93" name="TextBox 39"/>
          <p:cNvSpPr txBox="1"/>
          <p:nvPr/>
        </p:nvSpPr>
        <p:spPr>
          <a:xfrm>
            <a:off x="8056107" y="5682236"/>
            <a:ext cx="5910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0</a:t>
            </a:r>
          </a:p>
        </p:txBody>
      </p:sp>
      <p:sp>
        <p:nvSpPr>
          <p:cNvPr id="94" name="TextBox 40"/>
          <p:cNvSpPr txBox="1"/>
          <p:nvPr/>
        </p:nvSpPr>
        <p:spPr>
          <a:xfrm>
            <a:off x="8056432" y="5086179"/>
            <a:ext cx="5910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5</a:t>
            </a:r>
          </a:p>
        </p:txBody>
      </p:sp>
      <p:sp>
        <p:nvSpPr>
          <p:cNvPr id="95" name="TextBox 41"/>
          <p:cNvSpPr txBox="1"/>
          <p:nvPr/>
        </p:nvSpPr>
        <p:spPr>
          <a:xfrm>
            <a:off x="8064684" y="4475774"/>
            <a:ext cx="596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10</a:t>
            </a:r>
          </a:p>
        </p:txBody>
      </p:sp>
      <p:sp>
        <p:nvSpPr>
          <p:cNvPr id="96" name="TextBox 42"/>
          <p:cNvSpPr txBox="1"/>
          <p:nvPr/>
        </p:nvSpPr>
        <p:spPr>
          <a:xfrm>
            <a:off x="8059060" y="3879717"/>
            <a:ext cx="608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15</a:t>
            </a:r>
          </a:p>
        </p:txBody>
      </p:sp>
      <p:sp>
        <p:nvSpPr>
          <p:cNvPr id="97" name="TextBox 43"/>
          <p:cNvSpPr txBox="1"/>
          <p:nvPr/>
        </p:nvSpPr>
        <p:spPr>
          <a:xfrm>
            <a:off x="8053528" y="3297307"/>
            <a:ext cx="608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20</a:t>
            </a:r>
          </a:p>
        </p:txBody>
      </p:sp>
      <p:sp>
        <p:nvSpPr>
          <p:cNvPr id="98" name="TextBox 54"/>
          <p:cNvSpPr txBox="1"/>
          <p:nvPr/>
        </p:nvSpPr>
        <p:spPr>
          <a:xfrm rot="16200000">
            <a:off x="6959832" y="4424129"/>
            <a:ext cx="18739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yrosine degradation (% of total readings)</a:t>
            </a:r>
          </a:p>
        </p:txBody>
      </p:sp>
      <p:sp>
        <p:nvSpPr>
          <p:cNvPr id="99" name="TextBox 65"/>
          <p:cNvSpPr txBox="1"/>
          <p:nvPr/>
        </p:nvSpPr>
        <p:spPr>
          <a:xfrm>
            <a:off x="8620081" y="5873890"/>
            <a:ext cx="6959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HAM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TextBox 66"/>
          <p:cNvSpPr txBox="1"/>
          <p:nvPr/>
        </p:nvSpPr>
        <p:spPr>
          <a:xfrm>
            <a:off x="9305691" y="5867602"/>
            <a:ext cx="6831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CA</a:t>
            </a:r>
          </a:p>
        </p:txBody>
      </p:sp>
      <p:sp>
        <p:nvSpPr>
          <p:cNvPr id="101" name="TextBox 74"/>
          <p:cNvSpPr txBox="1"/>
          <p:nvPr/>
        </p:nvSpPr>
        <p:spPr>
          <a:xfrm>
            <a:off x="7655204" y="3168909"/>
            <a:ext cx="2815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102" name="TextBox 61"/>
          <p:cNvSpPr txBox="1"/>
          <p:nvPr/>
        </p:nvSpPr>
        <p:spPr>
          <a:xfrm>
            <a:off x="10030660" y="5853070"/>
            <a:ext cx="5302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CAP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TextBox 23"/>
          <p:cNvSpPr txBox="1"/>
          <p:nvPr/>
        </p:nvSpPr>
        <p:spPr>
          <a:xfrm>
            <a:off x="226355" y="6138201"/>
            <a:ext cx="11621087" cy="10147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. Effect of captopril on SCFAs and the abundance of bacteria involved in amino acid metabolis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ontent of acetate, butyrate and lactate in feces (A); Percentage of bacteria involved in tryptophan degradation (B), tryptophan biosynthesis (C), glutamate degradation (D), arginine degradation (E) and tyrosine degradation (F) predicted in the gut microbiota of DOCA-salt hypertensive SD rats. Results were compared by one-way ANOVA and Duncan post hoc test; *p &lt; 0.05, **p &lt; 0.01 and ***p &lt; 0.001. ns, not significant; n = 4.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6" name="Straight Connector 105"/>
          <p:cNvCxnSpPr/>
          <p:nvPr/>
        </p:nvCxnSpPr>
        <p:spPr>
          <a:xfrm>
            <a:off x="5450213" y="660649"/>
            <a:ext cx="54864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Rectangle 106"/>
          <p:cNvSpPr/>
          <p:nvPr/>
        </p:nvSpPr>
        <p:spPr>
          <a:xfrm>
            <a:off x="5592099" y="495569"/>
            <a:ext cx="2741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cxnSp>
        <p:nvCxnSpPr>
          <p:cNvPr id="108" name="Straight Connector 107"/>
          <p:cNvCxnSpPr/>
          <p:nvPr/>
        </p:nvCxnSpPr>
        <p:spPr>
          <a:xfrm>
            <a:off x="8655146" y="659505"/>
            <a:ext cx="6400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Rectangle 108"/>
          <p:cNvSpPr/>
          <p:nvPr/>
        </p:nvSpPr>
        <p:spPr>
          <a:xfrm>
            <a:off x="8840576" y="494425"/>
            <a:ext cx="2741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cxnSp>
        <p:nvCxnSpPr>
          <p:cNvPr id="110" name="Straight Connector 109"/>
          <p:cNvCxnSpPr/>
          <p:nvPr/>
        </p:nvCxnSpPr>
        <p:spPr>
          <a:xfrm>
            <a:off x="1729572" y="3970054"/>
            <a:ext cx="6400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Rectangle 110"/>
          <p:cNvSpPr/>
          <p:nvPr/>
        </p:nvSpPr>
        <p:spPr>
          <a:xfrm>
            <a:off x="1928367" y="3799359"/>
            <a:ext cx="2741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cxnSp>
        <p:nvCxnSpPr>
          <p:cNvPr id="112" name="Straight Connector 111"/>
          <p:cNvCxnSpPr/>
          <p:nvPr/>
        </p:nvCxnSpPr>
        <p:spPr>
          <a:xfrm>
            <a:off x="5588845" y="3763223"/>
            <a:ext cx="6400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Rectangle 112"/>
          <p:cNvSpPr/>
          <p:nvPr/>
        </p:nvSpPr>
        <p:spPr>
          <a:xfrm>
            <a:off x="5787640" y="3592528"/>
            <a:ext cx="2741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cxnSp>
        <p:nvCxnSpPr>
          <p:cNvPr id="114" name="Straight Connector 113"/>
          <p:cNvCxnSpPr/>
          <p:nvPr/>
        </p:nvCxnSpPr>
        <p:spPr>
          <a:xfrm>
            <a:off x="6163214" y="660177"/>
            <a:ext cx="731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Rectangle 114"/>
          <p:cNvSpPr/>
          <p:nvPr/>
        </p:nvSpPr>
        <p:spPr>
          <a:xfrm>
            <a:off x="6369081" y="411918"/>
            <a:ext cx="40649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s</a:t>
            </a:r>
          </a:p>
        </p:txBody>
      </p:sp>
      <p:cxnSp>
        <p:nvCxnSpPr>
          <p:cNvPr id="116" name="Straight Connector 115"/>
          <p:cNvCxnSpPr/>
          <p:nvPr/>
        </p:nvCxnSpPr>
        <p:spPr>
          <a:xfrm>
            <a:off x="9429767" y="660177"/>
            <a:ext cx="731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Rectangle 116"/>
          <p:cNvSpPr/>
          <p:nvPr/>
        </p:nvSpPr>
        <p:spPr>
          <a:xfrm>
            <a:off x="9635634" y="411918"/>
            <a:ext cx="40649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s</a:t>
            </a:r>
          </a:p>
        </p:txBody>
      </p:sp>
      <p:cxnSp>
        <p:nvCxnSpPr>
          <p:cNvPr id="118" name="Straight Connector 117"/>
          <p:cNvCxnSpPr/>
          <p:nvPr/>
        </p:nvCxnSpPr>
        <p:spPr>
          <a:xfrm>
            <a:off x="2447587" y="3967514"/>
            <a:ext cx="731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Rectangle 118"/>
          <p:cNvSpPr/>
          <p:nvPr/>
        </p:nvSpPr>
        <p:spPr>
          <a:xfrm>
            <a:off x="2653454" y="3719255"/>
            <a:ext cx="40649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s</a:t>
            </a:r>
          </a:p>
        </p:txBody>
      </p:sp>
      <p:cxnSp>
        <p:nvCxnSpPr>
          <p:cNvPr id="120" name="Straight Connector 119"/>
          <p:cNvCxnSpPr/>
          <p:nvPr/>
        </p:nvCxnSpPr>
        <p:spPr>
          <a:xfrm>
            <a:off x="6310900" y="3755843"/>
            <a:ext cx="731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Rectangle 120"/>
          <p:cNvSpPr/>
          <p:nvPr/>
        </p:nvSpPr>
        <p:spPr>
          <a:xfrm>
            <a:off x="6516767" y="3507584"/>
            <a:ext cx="40649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s</a:t>
            </a:r>
          </a:p>
        </p:txBody>
      </p:sp>
      <p:cxnSp>
        <p:nvCxnSpPr>
          <p:cNvPr id="122" name="Straight Connector 121"/>
          <p:cNvCxnSpPr/>
          <p:nvPr/>
        </p:nvCxnSpPr>
        <p:spPr>
          <a:xfrm>
            <a:off x="8816355" y="3971132"/>
            <a:ext cx="731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Rectangle 122"/>
          <p:cNvSpPr/>
          <p:nvPr/>
        </p:nvSpPr>
        <p:spPr>
          <a:xfrm>
            <a:off x="9022222" y="3722873"/>
            <a:ext cx="40649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s</a:t>
            </a:r>
          </a:p>
        </p:txBody>
      </p:sp>
      <p:cxnSp>
        <p:nvCxnSpPr>
          <p:cNvPr id="124" name="Straight Connector 123"/>
          <p:cNvCxnSpPr/>
          <p:nvPr/>
        </p:nvCxnSpPr>
        <p:spPr>
          <a:xfrm>
            <a:off x="9621547" y="3971132"/>
            <a:ext cx="731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Rectangle 124"/>
          <p:cNvSpPr/>
          <p:nvPr/>
        </p:nvSpPr>
        <p:spPr>
          <a:xfrm>
            <a:off x="9827414" y="3722873"/>
            <a:ext cx="40649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s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5</TotalTime>
  <Words>708</Words>
  <Application>Microsoft Office PowerPoint</Application>
  <PresentationFormat>自定义</PresentationFormat>
  <Paragraphs>317</Paragraphs>
  <Slides>5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6" baseType="lpstr">
      <vt:lpstr>Office Theme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ber2</dc:creator>
  <cp:lastModifiedBy>1</cp:lastModifiedBy>
  <cp:revision>90</cp:revision>
  <dcterms:created xsi:type="dcterms:W3CDTF">2019-09-26T06:43:00Z</dcterms:created>
  <dcterms:modified xsi:type="dcterms:W3CDTF">2021-05-13T09:16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991</vt:lpwstr>
  </property>
</Properties>
</file>